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4"/>
  </p:handoutMasterIdLst>
  <p:sldIdLst>
    <p:sldId id="342" r:id="rId2"/>
    <p:sldId id="257" r:id="rId3"/>
  </p:sldIdLst>
  <p:sldSz cx="12192000" cy="6858000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04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2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# of discussed pts </c:v>
                </c:pt>
              </c:strCache>
            </c:strRef>
          </c:tx>
          <c:spPr>
            <a:solidFill>
              <a:srgbClr val="7030A0"/>
            </a:solidFill>
            <a:ln w="6350">
              <a:solidFill>
                <a:schemeClr val="bg1">
                  <a:lumMod val="75000"/>
                </a:schemeClr>
              </a:solidFill>
            </a:ln>
          </c:spPr>
          <c:invertIfNegative val="0"/>
          <c:cat>
            <c:numRef>
              <c:f>Tabelle1!$A$2:$A$11</c:f>
              <c:numCache>
                <c:formatCode>General</c:formatCode>
                <c:ptCount val="10"/>
                <c:pt idx="0">
                  <c:v>2012</c:v>
                </c:pt>
                <c:pt idx="1">
                  <c:v>2013</c:v>
                </c:pt>
                <c:pt idx="2">
                  <c:v>2014</c:v>
                </c:pt>
                <c:pt idx="3">
                  <c:v>2015</c:v>
                </c:pt>
                <c:pt idx="4">
                  <c:v>2016</c:v>
                </c:pt>
                <c:pt idx="5">
                  <c:v>2017</c:v>
                </c:pt>
                <c:pt idx="6">
                  <c:v>2018</c:v>
                </c:pt>
                <c:pt idx="7">
                  <c:v>2019</c:v>
                </c:pt>
                <c:pt idx="8">
                  <c:v>2020</c:v>
                </c:pt>
                <c:pt idx="9">
                  <c:v>2021</c:v>
                </c:pt>
              </c:numCache>
            </c:numRef>
          </c:cat>
          <c:val>
            <c:numRef>
              <c:f>Tabelle1!$B$2:$B$11</c:f>
              <c:numCache>
                <c:formatCode>General</c:formatCode>
                <c:ptCount val="10"/>
                <c:pt idx="0">
                  <c:v>215</c:v>
                </c:pt>
                <c:pt idx="1">
                  <c:v>187</c:v>
                </c:pt>
                <c:pt idx="2">
                  <c:v>191</c:v>
                </c:pt>
                <c:pt idx="3">
                  <c:v>248</c:v>
                </c:pt>
                <c:pt idx="4">
                  <c:v>280</c:v>
                </c:pt>
                <c:pt idx="5">
                  <c:v>357</c:v>
                </c:pt>
                <c:pt idx="6">
                  <c:v>263</c:v>
                </c:pt>
                <c:pt idx="7">
                  <c:v>303</c:v>
                </c:pt>
                <c:pt idx="8">
                  <c:v>324</c:v>
                </c:pt>
                <c:pt idx="9">
                  <c:v>2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68-4457-8996-5A948958D2ED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Spalte1</c:v>
                </c:pt>
              </c:strCache>
            </c:strRef>
          </c:tx>
          <c:spPr>
            <a:solidFill>
              <a:srgbClr val="C00000"/>
            </a:solidFill>
          </c:spPr>
          <c:invertIfNegative val="0"/>
          <c:cat>
            <c:numRef>
              <c:f>Tabelle1!$A$2:$A$11</c:f>
              <c:numCache>
                <c:formatCode>General</c:formatCode>
                <c:ptCount val="10"/>
                <c:pt idx="0">
                  <c:v>2012</c:v>
                </c:pt>
                <c:pt idx="1">
                  <c:v>2013</c:v>
                </c:pt>
                <c:pt idx="2">
                  <c:v>2014</c:v>
                </c:pt>
                <c:pt idx="3">
                  <c:v>2015</c:v>
                </c:pt>
                <c:pt idx="4">
                  <c:v>2016</c:v>
                </c:pt>
                <c:pt idx="5">
                  <c:v>2017</c:v>
                </c:pt>
                <c:pt idx="6">
                  <c:v>2018</c:v>
                </c:pt>
                <c:pt idx="7">
                  <c:v>2019</c:v>
                </c:pt>
                <c:pt idx="8">
                  <c:v>2020</c:v>
                </c:pt>
                <c:pt idx="9">
                  <c:v>2021</c:v>
                </c:pt>
              </c:numCache>
            </c:numRef>
          </c:cat>
          <c:val>
            <c:numRef>
              <c:f>Tabelle1!$C$2:$C$11</c:f>
              <c:numCache>
                <c:formatCode>General</c:formatCode>
                <c:ptCount val="10"/>
              </c:numCache>
            </c:numRef>
          </c:val>
          <c:extLst>
            <c:ext xmlns:c16="http://schemas.microsoft.com/office/drawing/2014/chart" uri="{C3380CC4-5D6E-409C-BE32-E72D297353CC}">
              <c16:uniqueId val="{00000001-E068-4457-8996-5A948958D2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5084416"/>
        <c:axId val="145085952"/>
      </c:barChart>
      <c:catAx>
        <c:axId val="145084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6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145085952"/>
        <c:crosses val="autoZero"/>
        <c:auto val="1"/>
        <c:lblAlgn val="ctr"/>
        <c:lblOffset val="100"/>
        <c:noMultiLvlLbl val="0"/>
      </c:catAx>
      <c:valAx>
        <c:axId val="14508595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600">
                <a:solidFill>
                  <a:srgbClr val="06060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145084416"/>
        <c:crosses val="autoZero"/>
        <c:crossBetween val="between"/>
      </c:valAx>
    </c:plotArea>
    <c:legend>
      <c:legendPos val="r"/>
      <c:legendEntry>
        <c:idx val="0"/>
        <c:delete val="1"/>
      </c:legendEntry>
      <c:layout/>
      <c:overlay val="0"/>
      <c:spPr>
        <a:solidFill>
          <a:schemeClr val="bg1"/>
        </a:solidFill>
      </c:spPr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de-DE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BFA0AD-F145-47B9-9046-EE488C779418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968EEC-DAE7-4370-813C-27000E5EAF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03592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8D898C6-95E4-4996-BD30-BED2418F73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B5FB8029-1A1F-45B7-A4CD-E63EBF33B4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BB30A0B-DC4A-4897-92FC-DB71B20FD7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80DC2D6-2CAC-40D7-94C1-62886AB8B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ED0FEF5-3C56-42C2-B365-D79A71CB3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1160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329AC14-9630-4284-8327-76C988F8E5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BB9042B-BFB1-4C2A-A990-6107C43F3B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D849981-D8D4-4315-9F9C-E6868D61E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0990C81-C677-4041-8A0F-1BC869473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55494AF-8E84-4335-A105-070623868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79241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755FCD02-07B2-4760-B7F2-635340A8C5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6412B6E-287F-4458-9918-84FB6DDF7E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1E57343-8B13-43EE-80CE-CC7D56A19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59DFD47-31C8-4CF0-9CD0-973FF5E152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21327BD-E923-4C71-9AAB-5B3D9A7FA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5838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3D2A79D-C0E1-4455-9CE6-DEDC1BBBE0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B08C93E-7C31-4B1C-B578-9B885A9A53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D3F6F42-51EF-41AA-A0D3-498560FD8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5C0041A-54C3-48C5-BED3-4EB458409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E143A30-C4A9-4EA1-8A85-C092A7729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2046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D5820ED-D805-4915-972C-A54F230698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89FEDF1-1D03-4BE2-8D0C-519E17C8C5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33CA9B5-74CA-4668-8F2E-832A9C05B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1913915-933C-4489-BB92-4E61A0AC7A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C99528B-66E1-42DF-9FA9-9136FF1B4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6346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7E489A9-A4AC-4DE6-AE96-58F4464F2A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9A1590C-68C1-4113-B3FF-3D5EB19650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C8EF337-860B-43DB-8AC6-FD40910966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D5453B4-CF4D-43B5-BA0B-CD102CB68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9C94660-E4EA-4B74-B47B-B1CFD416A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2872C6A-41EB-4187-9275-437A189D8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3692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558CC7B-10D8-4A03-8CDF-0580D72DE6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9A5AB3F-3521-41C9-A78D-CB24A26B53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D9BED9C-29A5-40AB-822B-511EE63411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EE9BF591-CE4A-4970-BCE5-28744900AD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95E9BB9-0349-4244-925C-2F151E2769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E1CEB2C-AFB3-43F7-BFE5-98049B5AC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D181BF4-7314-4D89-BCE7-07C41F15E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A7E71B15-F39F-473B-A481-AB8E54ED3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6099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C9F52D-43BC-4F0A-8621-9219C630F4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0EF37110-BC9C-4F86-8CEC-935F1359E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66A6221-E236-401D-AD37-B567F96EBF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D7EBBB8-989D-4898-AF6F-5EC5644D7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1138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1F4FA4B7-51C3-4FDA-B32A-80E1EB4B5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4750140-27F2-45C4-A2EC-4BA8B1FEB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DA214F1D-B32F-4D22-83C1-92E827B42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6762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4EF0CA-4636-4E1B-905D-7D9E53E48A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EDED3E9-92DD-4437-B1D9-18006B90BD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A351326-751A-44D9-BBBA-AA62681C47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9DDF863-3EB6-47AF-BF29-EFD7CC699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F3D6AB3-67B5-4120-A264-D572F446D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9396F20-D7CD-4DC2-A619-A49B97BD7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4688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2F46CD5-F361-45DD-94E3-7AFD45E8BE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C88EA13B-C49A-40DE-98C6-BC4749BC06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569EB88-DC3A-44A6-87CC-D1B7A82E17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198890F-C0EA-435A-A99F-82B9464C6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9499820-13A0-4226-90E6-D75D4D7AB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D34CE1F-8BE5-4E59-872B-C40DF4BAB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1618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03FDEAA-87F2-4CD8-9E42-04A4E1C4DB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F41BA8E-BB7B-496F-B388-CC992F3CF7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D081FF3-8790-4BD0-A765-1F7A816A1B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11751-10F5-4DC0-9887-2036C10E6620}" type="datetimeFigureOut">
              <a:rPr lang="de-DE" smtClean="0"/>
              <a:t>06.07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DEE733A-5341-41BF-B3D6-27B9F5FAEE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CC930E9-ABA3-4945-8042-A5CD486DCF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70E9C-2484-465B-825E-B3B3CC998C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1137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m 4"/>
          <p:cNvGraphicFramePr/>
          <p:nvPr>
            <p:extLst>
              <p:ext uri="{D42A27DB-BD31-4B8C-83A1-F6EECF244321}">
                <p14:modId xmlns:p14="http://schemas.microsoft.com/office/powerpoint/2010/main" val="1118704874"/>
              </p:ext>
            </p:extLst>
          </p:nvPr>
        </p:nvGraphicFramePr>
        <p:xfrm>
          <a:off x="1564061" y="429360"/>
          <a:ext cx="10088963" cy="34383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feld 7"/>
          <p:cNvSpPr txBox="1"/>
          <p:nvPr/>
        </p:nvSpPr>
        <p:spPr>
          <a:xfrm rot="16200000">
            <a:off x="219233" y="1917690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35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srgbClr val="080808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Number of pts / year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DDE422A2-7A8A-EBBE-EF11-8A4E7434528B}"/>
              </a:ext>
            </a:extLst>
          </p:cNvPr>
          <p:cNvSpPr txBox="1"/>
          <p:nvPr/>
        </p:nvSpPr>
        <p:spPr>
          <a:xfrm>
            <a:off x="251498" y="6530041"/>
            <a:ext cx="119405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 Figure 1A+B. Myeloma pts in MM-TB Freiburg / year</a:t>
            </a:r>
            <a:endParaRPr lang="de-DE" sz="1200" dirty="0"/>
          </a:p>
        </p:txBody>
      </p:sp>
      <p:sp>
        <p:nvSpPr>
          <p:cNvPr id="2" name="Textfeld 1"/>
          <p:cNvSpPr txBox="1"/>
          <p:nvPr/>
        </p:nvSpPr>
        <p:spPr>
          <a:xfrm>
            <a:off x="724465" y="435606"/>
            <a:ext cx="616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7" name="Tabelle 6">
            <a:extLst>
              <a:ext uri="{FF2B5EF4-FFF2-40B4-BE49-F238E27FC236}">
                <a16:creationId xmlns:a16="http://schemas.microsoft.com/office/drawing/2014/main" id="{22A4BB48-9E31-184F-7B6C-642ADCBED5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277116"/>
              </p:ext>
            </p:extLst>
          </p:nvPr>
        </p:nvGraphicFramePr>
        <p:xfrm>
          <a:off x="1539731" y="4223451"/>
          <a:ext cx="7812000" cy="150300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5328000">
                  <a:extLst>
                    <a:ext uri="{9D8B030D-6E8A-4147-A177-3AD203B41FA5}">
                      <a16:colId xmlns:a16="http://schemas.microsoft.com/office/drawing/2014/main" val="2742416824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2520837853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3241875685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2120119334"/>
                    </a:ext>
                  </a:extLst>
                </a:gridCol>
              </a:tblGrid>
              <a:tr h="180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500" b="1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-TB </a:t>
                      </a:r>
                      <a:r>
                        <a:rPr lang="de-DE" sz="1500" b="1" baseline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ults</a:t>
                      </a:r>
                      <a:r>
                        <a:rPr lang="de-DE" sz="1500" b="1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019-21</a:t>
                      </a:r>
                      <a:endParaRPr lang="de-DE" sz="1500" b="1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500" b="1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2019</a:t>
                      </a:r>
                      <a:endParaRPr lang="de-DE" sz="1500" b="1" baseline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500" b="1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2020</a:t>
                      </a:r>
                      <a:endParaRPr lang="de-DE" sz="1500" b="1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500" b="1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2021</a:t>
                      </a:r>
                      <a:endParaRPr lang="de-DE" sz="1500" b="1" baseline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0480562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5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MM-TBs / </a:t>
                      </a:r>
                      <a:r>
                        <a:rPr lang="de-DE" sz="1500" baseline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ar</a:t>
                      </a:r>
                      <a:endParaRPr lang="de-DE" sz="1500" b="0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de-DE" sz="1400" b="0" baseline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de-DE" sz="1400" b="0" baseline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  <a:endParaRPr lang="de-DE" sz="1400" b="0" baseline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2936640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5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istered / </a:t>
                      </a:r>
                      <a:r>
                        <a:rPr lang="de-DE" sz="1500" baseline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ussed</a:t>
                      </a:r>
                      <a:r>
                        <a:rPr lang="de-DE" sz="15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B-</a:t>
                      </a:r>
                      <a:r>
                        <a:rPr lang="de-DE" sz="1500" baseline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</a:t>
                      </a:r>
                      <a:endParaRPr lang="de-DE" sz="1500" b="0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6 / 446</a:t>
                      </a:r>
                      <a:endParaRPr lang="de-DE" sz="1400" b="0" baseline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5 / 455</a:t>
                      </a:r>
                      <a:endParaRPr lang="de-DE" sz="1400" b="0" baseline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8 / 414</a:t>
                      </a:r>
                      <a:endParaRPr lang="de-DE" sz="1400" b="0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8758897"/>
                  </a:ext>
                </a:extLst>
              </a:tr>
              <a:tr h="180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5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# of interdisciplinarily discussed entire / RRMM pts</a:t>
                      </a:r>
                      <a:endParaRPr lang="de-DE" sz="1500" b="0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 / 239</a:t>
                      </a:r>
                      <a:endParaRPr lang="de-DE" sz="1400" b="0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4 / 235</a:t>
                      </a:r>
                      <a:endParaRPr lang="de-DE" sz="1400" b="0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8 / 213</a:t>
                      </a:r>
                      <a:endParaRPr lang="de-DE" sz="1400" b="0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5701838"/>
                  </a:ext>
                </a:extLst>
              </a:tr>
              <a:tr h="226652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5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# </a:t>
                      </a:r>
                      <a:r>
                        <a:rPr lang="de-DE" sz="15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 interdisciplinarily discussed </a:t>
                      </a:r>
                      <a:r>
                        <a:rPr lang="en-US" sz="15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 MM pts </a:t>
                      </a:r>
                      <a:r>
                        <a:rPr lang="de-DE" sz="15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 </a:t>
                      </a:r>
                      <a:r>
                        <a:rPr lang="de-DE" sz="1500" baseline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1500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ntire pts)</a:t>
                      </a:r>
                      <a:endParaRPr lang="de-DE" sz="1500" b="0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 (21%) </a:t>
                      </a:r>
                      <a:endParaRPr lang="de-DE" sz="1400" b="0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 (27%)</a:t>
                      </a:r>
                      <a:endParaRPr lang="de-DE" sz="1400" b="0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b="0" baseline="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5 (29%)</a:t>
                      </a:r>
                      <a:endParaRPr lang="de-DE" sz="1400" b="0" baseline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6006461"/>
                  </a:ext>
                </a:extLst>
              </a:tr>
            </a:tbl>
          </a:graphicData>
        </a:graphic>
      </p:graphicFrame>
      <p:sp>
        <p:nvSpPr>
          <p:cNvPr id="11" name="Textfeld 10"/>
          <p:cNvSpPr txBox="1"/>
          <p:nvPr/>
        </p:nvSpPr>
        <p:spPr>
          <a:xfrm>
            <a:off x="750745" y="4129985"/>
            <a:ext cx="616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1548863" y="5706942"/>
            <a:ext cx="73058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</a:pP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bbrevatio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>
              <a:lnSpc>
                <a:spcPts val="1200"/>
              </a:lnSpc>
            </a:pP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RRMM</a:t>
            </a:r>
            <a:r>
              <a:rPr lang="de-DE" sz="110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100">
                <a:latin typeface="Arial" panose="020B0604020202020204" pitchFamily="34" charset="0"/>
                <a:cs typeface="Arial" panose="020B0604020202020204" pitchFamily="34" charset="0"/>
              </a:rPr>
              <a:t>pts</a:t>
            </a:r>
            <a:r>
              <a:rPr lang="de-DE" sz="110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100" smtClean="0">
                <a:latin typeface="Arial" panose="020B0604020202020204" pitchFamily="34" charset="0"/>
                <a:cs typeface="Arial" panose="020B0604020202020204" pitchFamily="34" charset="0"/>
              </a:rPr>
              <a:t>patients, </a:t>
            </a:r>
            <a:r>
              <a:rPr lang="de-DE" sz="1100">
                <a:latin typeface="Arial" panose="020B0604020202020204" pitchFamily="34" charset="0"/>
                <a:cs typeface="Arial" panose="020B0604020202020204" pitchFamily="34" charset="0"/>
              </a:rPr>
              <a:t>TB: </a:t>
            </a:r>
            <a:r>
              <a:rPr lang="de-DE" sz="1100">
                <a:latin typeface="Arial" panose="020B0604020202020204" pitchFamily="34" charset="0"/>
                <a:cs typeface="Arial" panose="020B0604020202020204" pitchFamily="34" charset="0"/>
              </a:rPr>
              <a:t>tumor </a:t>
            </a:r>
            <a:r>
              <a:rPr lang="de-DE" sz="1100" smtClean="0">
                <a:latin typeface="Arial" panose="020B0604020202020204" pitchFamily="34" charset="0"/>
                <a:cs typeface="Arial" panose="020B0604020202020204" pitchFamily="34" charset="0"/>
              </a:rPr>
              <a:t>board, relapsed/refractory </a:t>
            </a:r>
            <a:r>
              <a:rPr lang="de-DE" sz="1100">
                <a:latin typeface="Arial" panose="020B0604020202020204" pitchFamily="34" charset="0"/>
                <a:cs typeface="Arial" panose="020B0604020202020204" pitchFamily="34" charset="0"/>
              </a:rPr>
              <a:t>multiple </a:t>
            </a:r>
            <a:r>
              <a:rPr lang="de-DE" sz="1100" smtClean="0">
                <a:latin typeface="Arial" panose="020B0604020202020204" pitchFamily="34" charset="0"/>
                <a:cs typeface="Arial" panose="020B0604020202020204" pitchFamily="34" charset="0"/>
              </a:rPr>
              <a:t>myeloma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de-DE" sz="110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ID: </a:t>
            </a:r>
            <a:r>
              <a:rPr lang="de-DE" sz="1100">
                <a:latin typeface="Arial" panose="020B0604020202020204" pitchFamily="34" charset="0"/>
                <a:cs typeface="Arial" panose="020B0604020202020204" pitchFamily="34" charset="0"/>
              </a:rPr>
              <a:t>initial </a:t>
            </a:r>
            <a:r>
              <a:rPr lang="de-DE" sz="1100" smtClean="0">
                <a:latin typeface="Arial" panose="020B0604020202020204" pitchFamily="34" charset="0"/>
                <a:cs typeface="Arial" panose="020B0604020202020204" pitchFamily="34" charset="0"/>
              </a:rPr>
              <a:t>diagnosis 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64767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AB362C2-83A1-4A87-BFAE-9887B2ADA7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6588076"/>
            <a:ext cx="12192000" cy="269924"/>
          </a:xfrm>
        </p:spPr>
        <p:txBody>
          <a:bodyPr>
            <a:noAutofit/>
          </a:bodyPr>
          <a:lstStyle/>
          <a:p>
            <a:pPr algn="r">
              <a:lnSpc>
                <a:spcPct val="107000"/>
              </a:lnSpc>
              <a:spcAft>
                <a:spcPts val="3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ure 2A+B. Calculation of time requirements for TB participants 03/20-02/21 vs. 2019 + 2018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878892" y="179889"/>
            <a:ext cx="2779068" cy="275973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 lIns="36000" tIns="36000" rIns="36000" bIns="36000" rtlCol="0">
            <a:spAutoFit/>
          </a:bodyPr>
          <a:lstStyle/>
          <a:p>
            <a:pPr defTabSz="36000">
              <a:lnSpc>
                <a:spcPts val="1300"/>
              </a:lnSpc>
            </a:pP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B-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eparation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03/20-02/21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-		44 TBs in 3/2020-3/2021</a:t>
            </a: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pprox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 30´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estimat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repara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time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u="sng" dirty="0" err="1">
                <a:latin typeface="Arial" panose="020B0604020202020204" pitchFamily="34" charset="0"/>
                <a:cs typeface="Arial" panose="020B0604020202020204" pitchFamily="34" charset="0"/>
              </a:rPr>
              <a:t>Calcula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I: Time /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44 TBs * 30´=1320´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II: Time /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1320´ : 312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pprox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4´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4771759" y="710428"/>
            <a:ext cx="2705029" cy="2259593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lIns="36000" tIns="36000" rIns="36000" bIns="36000" rtlCol="0">
            <a:spAutoFit/>
          </a:bodyPr>
          <a:lstStyle/>
          <a:p>
            <a:pPr>
              <a:lnSpc>
                <a:spcPts val="1300"/>
              </a:lnSpc>
            </a:pP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B-performance 03/20-02/21</a:t>
            </a: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- 44 TBs</a:t>
            </a: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- 60´ TB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dura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u="sng" dirty="0" err="1">
                <a:latin typeface="Arial" panose="020B0604020202020204" pitchFamily="34" charset="0"/>
                <a:cs typeface="Arial" panose="020B0604020202020204" pitchFamily="34" charset="0"/>
              </a:rPr>
              <a:t>Calcula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I: </a:t>
            </a:r>
            <a:r>
              <a:rPr lang="de-DE" sz="1400">
                <a:latin typeface="Arial" panose="020B0604020202020204" pitchFamily="34" charset="0"/>
                <a:cs typeface="Arial" panose="020B0604020202020204" pitchFamily="34" charset="0"/>
              </a:rPr>
              <a:t>44 TBs 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* 60´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= 2640´/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II: 2640´ : 312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pprox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8´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8583912" y="222346"/>
            <a:ext cx="2882183" cy="275973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txBody>
          <a:bodyPr wrap="square" lIns="36000" tIns="36000" rIns="36000" bIns="36000" rtlCol="0">
            <a:spAutoFit/>
          </a:bodyPr>
          <a:lstStyle/>
          <a:p>
            <a:pPr>
              <a:lnSpc>
                <a:spcPts val="1300"/>
              </a:lnSpc>
            </a:pP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B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cessing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03/20-03/21</a:t>
            </a:r>
          </a:p>
          <a:p>
            <a:pPr>
              <a:lnSpc>
                <a:spcPts val="1300"/>
              </a:lnSpc>
            </a:pP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- 44 TBs</a:t>
            </a: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- 10´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repara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estimat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u="sng" dirty="0" err="1">
                <a:latin typeface="Arial" panose="020B0604020202020204" pitchFamily="34" charset="0"/>
                <a:cs typeface="Arial" panose="020B0604020202020204" pitchFamily="34" charset="0"/>
              </a:rPr>
              <a:t>Calcula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I: 44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B´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* 10´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= 440´/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II: 440´ : 312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pprox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1´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300"/>
              </a:lnSpc>
            </a:pP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300"/>
              </a:lnSpc>
            </a:pP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∑ 4´+8´+1´=13´</a:t>
            </a:r>
          </a:p>
        </p:txBody>
      </p:sp>
      <p:cxnSp>
        <p:nvCxnSpPr>
          <p:cNvPr id="8" name="Gerade Verbindung mit Pfeil 7"/>
          <p:cNvCxnSpPr>
            <a:cxnSpLocks/>
          </p:cNvCxnSpPr>
          <p:nvPr/>
        </p:nvCxnSpPr>
        <p:spPr>
          <a:xfrm>
            <a:off x="3866270" y="2769279"/>
            <a:ext cx="789951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feld 9"/>
          <p:cNvSpPr txBox="1"/>
          <p:nvPr/>
        </p:nvSpPr>
        <p:spPr>
          <a:xfrm>
            <a:off x="212378" y="94728"/>
            <a:ext cx="616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238658" y="3235647"/>
            <a:ext cx="616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A1424E99-C01E-0F6B-C387-1B67C8A3A08A}"/>
              </a:ext>
            </a:extLst>
          </p:cNvPr>
          <p:cNvSpPr txBox="1"/>
          <p:nvPr/>
        </p:nvSpPr>
        <p:spPr>
          <a:xfrm>
            <a:off x="878891" y="3341717"/>
            <a:ext cx="2779068" cy="109260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 lIns="36000" tIns="36000" rIns="36000" bIns="36000" rtlCol="0">
            <a:spAutoFit/>
          </a:bodyPr>
          <a:lstStyle/>
          <a:p>
            <a:pPr>
              <a:lnSpc>
                <a:spcPts val="1300"/>
              </a:lnSpc>
            </a:pP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B-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eparation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2019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Final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alcula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e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 03/20-02/21):</a:t>
            </a:r>
          </a:p>
          <a:p>
            <a:pPr>
              <a:lnSpc>
                <a:spcPts val="1300"/>
              </a:lnSpc>
            </a:pP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300"/>
              </a:lnSpc>
            </a:pP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pprox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4´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DA4400E8-DBD2-AED4-6C4C-51E28D251DFF}"/>
              </a:ext>
            </a:extLst>
          </p:cNvPr>
          <p:cNvSpPr txBox="1"/>
          <p:nvPr/>
        </p:nvSpPr>
        <p:spPr>
          <a:xfrm>
            <a:off x="4808621" y="3503882"/>
            <a:ext cx="2705029" cy="92589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lIns="36000" tIns="36000" rIns="36000" bIns="36000" rtlCol="0">
            <a:spAutoFit/>
          </a:bodyPr>
          <a:lstStyle/>
          <a:p>
            <a:pPr>
              <a:lnSpc>
                <a:spcPts val="1300"/>
              </a:lnSpc>
            </a:pP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B-performance 2019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Final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pprox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8´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07FFF3C7-ED0D-4081-ADDC-E055B96F23A7}"/>
              </a:ext>
            </a:extLst>
          </p:cNvPr>
          <p:cNvSpPr txBox="1"/>
          <p:nvPr/>
        </p:nvSpPr>
        <p:spPr>
          <a:xfrm>
            <a:off x="8583911" y="3207549"/>
            <a:ext cx="2882183" cy="125931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txBody>
          <a:bodyPr wrap="square" lIns="36000" tIns="36000" rIns="36000" bIns="36000" rtlCol="0">
            <a:spAutoFit/>
          </a:bodyPr>
          <a:lstStyle/>
          <a:p>
            <a:pPr>
              <a:lnSpc>
                <a:spcPts val="1300"/>
              </a:lnSpc>
            </a:pP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B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cessing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2019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Final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pprox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1´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∑ 4´+8´+1´=13´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3E2CA8F5-9F7C-F4AF-FEAC-7F0989D068D1}"/>
              </a:ext>
            </a:extLst>
          </p:cNvPr>
          <p:cNvSpPr txBox="1"/>
          <p:nvPr/>
        </p:nvSpPr>
        <p:spPr>
          <a:xfrm>
            <a:off x="867621" y="4526714"/>
            <a:ext cx="2779068" cy="109260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 lIns="36000" tIns="36000" rIns="36000" bIns="36000" rtlCol="0">
            <a:spAutoFit/>
          </a:bodyPr>
          <a:lstStyle/>
          <a:p>
            <a:pPr>
              <a:lnSpc>
                <a:spcPts val="1300"/>
              </a:lnSpc>
            </a:pP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B-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eparation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2018</a:t>
            </a:r>
          </a:p>
          <a:p>
            <a:pPr>
              <a:lnSpc>
                <a:spcPts val="1300"/>
              </a:lnSpc>
            </a:pP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Final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sul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alcula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e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 03/20-02/21):</a:t>
            </a:r>
          </a:p>
          <a:p>
            <a:pPr>
              <a:lnSpc>
                <a:spcPts val="1300"/>
              </a:lnSpc>
            </a:pP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300"/>
              </a:lnSpc>
            </a:pP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pprox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5´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1AE1232C-4279-8057-0ECA-C3677FFCED19}"/>
              </a:ext>
            </a:extLst>
          </p:cNvPr>
          <p:cNvSpPr txBox="1"/>
          <p:nvPr/>
        </p:nvSpPr>
        <p:spPr>
          <a:xfrm>
            <a:off x="4777069" y="4732500"/>
            <a:ext cx="2705029" cy="92589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lIns="36000" tIns="36000" rIns="36000" bIns="36000" rtlCol="0">
            <a:spAutoFit/>
          </a:bodyPr>
          <a:lstStyle/>
          <a:p>
            <a:pPr>
              <a:lnSpc>
                <a:spcPts val="1300"/>
              </a:lnSpc>
            </a:pP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B-performance 2018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Final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pprox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9´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6CBB4185-53EA-2CF5-AA8C-C3864BD56925}"/>
              </a:ext>
            </a:extLst>
          </p:cNvPr>
          <p:cNvSpPr txBox="1"/>
          <p:nvPr/>
        </p:nvSpPr>
        <p:spPr>
          <a:xfrm>
            <a:off x="8607177" y="4715172"/>
            <a:ext cx="2858917" cy="125931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txBody>
          <a:bodyPr wrap="square" lIns="36000" tIns="36000" rIns="36000" bIns="36000" rtlCol="0">
            <a:spAutoFit/>
          </a:bodyPr>
          <a:lstStyle/>
          <a:p>
            <a:pPr>
              <a:lnSpc>
                <a:spcPts val="1300"/>
              </a:lnSpc>
            </a:pP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B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cessing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2018</a:t>
            </a:r>
          </a:p>
          <a:p>
            <a:pPr>
              <a:lnSpc>
                <a:spcPts val="1300"/>
              </a:lnSpc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Final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pprox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2´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articipant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∑ 5´+9´+2´=16´</a:t>
            </a:r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D36210E1-74FD-6917-14C0-A0D1BB2EB24E}"/>
              </a:ext>
            </a:extLst>
          </p:cNvPr>
          <p:cNvSpPr/>
          <p:nvPr/>
        </p:nvSpPr>
        <p:spPr>
          <a:xfrm>
            <a:off x="838386" y="5984484"/>
            <a:ext cx="6368524" cy="45490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r>
              <a:rPr lang="de-DE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18: n = 263 </a:t>
            </a:r>
            <a:r>
              <a:rPr lang="de-DE" sz="1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s</a:t>
            </a:r>
            <a:r>
              <a:rPr lang="de-DE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41 TBs in </a:t>
            </a:r>
            <a:r>
              <a:rPr lang="de-DE" sz="1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de-DE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val</a:t>
            </a:r>
            <a:r>
              <a:rPr lang="de-DE" sz="1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a</a:t>
            </a:r>
            <a:r>
              <a:rPr lang="de-DE" sz="140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rox</a:t>
            </a:r>
            <a:r>
              <a:rPr lang="de-DE" sz="1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40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9 </a:t>
            </a:r>
            <a:r>
              <a:rPr lang="de-DE" sz="1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ticipants</a:t>
            </a:r>
            <a:r>
              <a:rPr lang="de-DE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TB/</a:t>
            </a:r>
            <a:r>
              <a:rPr lang="de-DE" sz="1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ek</a:t>
            </a:r>
            <a:r>
              <a:rPr lang="de-DE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19: n = 303 </a:t>
            </a:r>
            <a:r>
              <a:rPr lang="de-DE" sz="1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s</a:t>
            </a:r>
            <a:r>
              <a:rPr lang="de-DE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42 TBs in </a:t>
            </a:r>
            <a:r>
              <a:rPr lang="de-DE" sz="1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de-DE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val</a:t>
            </a:r>
            <a:r>
              <a:rPr lang="de-DE" sz="1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a</a:t>
            </a:r>
            <a:r>
              <a:rPr lang="de-DE" sz="140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rox</a:t>
            </a:r>
            <a:r>
              <a:rPr lang="de-DE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10 </a:t>
            </a:r>
            <a:r>
              <a:rPr lang="de-DE" sz="1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ticipants</a:t>
            </a:r>
            <a:r>
              <a:rPr lang="de-DE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TB/</a:t>
            </a:r>
            <a:r>
              <a:rPr lang="de-DE" sz="1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ek</a:t>
            </a:r>
            <a:endParaRPr lang="de-DE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Gerade Verbindung mit Pfeil 20">
            <a:extLst>
              <a:ext uri="{FF2B5EF4-FFF2-40B4-BE49-F238E27FC236}">
                <a16:creationId xmlns:a16="http://schemas.microsoft.com/office/drawing/2014/main" id="{02044E65-573F-8D6C-F265-E77F1E420FA2}"/>
              </a:ext>
            </a:extLst>
          </p:cNvPr>
          <p:cNvCxnSpPr>
            <a:cxnSpLocks/>
          </p:cNvCxnSpPr>
          <p:nvPr/>
        </p:nvCxnSpPr>
        <p:spPr>
          <a:xfrm>
            <a:off x="7651203" y="2769279"/>
            <a:ext cx="789951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id="{427F6D00-1469-366E-9711-CD2B0A77C409}"/>
              </a:ext>
            </a:extLst>
          </p:cNvPr>
          <p:cNvCxnSpPr>
            <a:cxnSpLocks/>
          </p:cNvCxnSpPr>
          <p:nvPr/>
        </p:nvCxnSpPr>
        <p:spPr>
          <a:xfrm>
            <a:off x="7651201" y="5477854"/>
            <a:ext cx="789951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>
            <a:extLst>
              <a:ext uri="{FF2B5EF4-FFF2-40B4-BE49-F238E27FC236}">
                <a16:creationId xmlns:a16="http://schemas.microsoft.com/office/drawing/2014/main" id="{2AEAB2ED-288D-6A79-C7D0-1969C9E39574}"/>
              </a:ext>
            </a:extLst>
          </p:cNvPr>
          <p:cNvCxnSpPr>
            <a:cxnSpLocks/>
          </p:cNvCxnSpPr>
          <p:nvPr/>
        </p:nvCxnSpPr>
        <p:spPr>
          <a:xfrm>
            <a:off x="3764164" y="5448665"/>
            <a:ext cx="789951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mit Pfeil 28">
            <a:extLst>
              <a:ext uri="{FF2B5EF4-FFF2-40B4-BE49-F238E27FC236}">
                <a16:creationId xmlns:a16="http://schemas.microsoft.com/office/drawing/2014/main" id="{90661AC6-A7FB-CDD0-7B94-1EFD16DD18B7}"/>
              </a:ext>
            </a:extLst>
          </p:cNvPr>
          <p:cNvCxnSpPr>
            <a:cxnSpLocks/>
          </p:cNvCxnSpPr>
          <p:nvPr/>
        </p:nvCxnSpPr>
        <p:spPr>
          <a:xfrm>
            <a:off x="7651202" y="4293279"/>
            <a:ext cx="789951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mit Pfeil 29">
            <a:extLst>
              <a:ext uri="{FF2B5EF4-FFF2-40B4-BE49-F238E27FC236}">
                <a16:creationId xmlns:a16="http://schemas.microsoft.com/office/drawing/2014/main" id="{59404971-96CA-70D4-069C-56A439F47904}"/>
              </a:ext>
            </a:extLst>
          </p:cNvPr>
          <p:cNvCxnSpPr>
            <a:cxnSpLocks/>
          </p:cNvCxnSpPr>
          <p:nvPr/>
        </p:nvCxnSpPr>
        <p:spPr>
          <a:xfrm>
            <a:off x="3866270" y="4293279"/>
            <a:ext cx="789951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91069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9</Words>
  <Application>Microsoft Office PowerPoint</Application>
  <PresentationFormat>Breitbild</PresentationFormat>
  <Paragraphs>59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Supplement Figure 2A+B. Calculation of time requirements for TB participants 03/20-02/21 vs. 2019 + 2018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earch Article</dc:title>
  <dc:creator>Benedikt Frank</dc:creator>
  <cp:lastModifiedBy>Prof. Dr. Monika Engelhardt</cp:lastModifiedBy>
  <cp:revision>80</cp:revision>
  <cp:lastPrinted>2022-06-07T16:25:38Z</cp:lastPrinted>
  <dcterms:created xsi:type="dcterms:W3CDTF">2022-04-23T07:55:05Z</dcterms:created>
  <dcterms:modified xsi:type="dcterms:W3CDTF">2022-07-06T12:59:57Z</dcterms:modified>
</cp:coreProperties>
</file>